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9" r:id="rId2"/>
  </p:sldIdLst>
  <p:sldSz cx="7772400" cy="10058400"/>
  <p:notesSz cx="6858000" cy="9144000"/>
  <p:defaultTextStyle>
    <a:defPPr>
      <a:defRPr lang="en-US"/>
    </a:defPPr>
    <a:lvl1pPr marL="0" algn="l" defTabSz="435437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1pPr>
    <a:lvl2pPr marL="217719" algn="l" defTabSz="435437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2pPr>
    <a:lvl3pPr marL="435437" algn="l" defTabSz="435437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3pPr>
    <a:lvl4pPr marL="653156" algn="l" defTabSz="435437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4pPr>
    <a:lvl5pPr marL="870875" algn="l" defTabSz="435437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5pPr>
    <a:lvl6pPr marL="1088593" algn="l" defTabSz="435437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6pPr>
    <a:lvl7pPr marL="1306312" algn="l" defTabSz="435437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7pPr>
    <a:lvl8pPr marL="1524030" algn="l" defTabSz="435437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8pPr>
    <a:lvl9pPr marL="1741749" algn="l" defTabSz="435437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08" autoAdjust="0"/>
    <p:restoredTop sz="94660"/>
  </p:normalViewPr>
  <p:slideViewPr>
    <p:cSldViewPr snapToGrid="0">
      <p:cViewPr varScale="1">
        <p:scale>
          <a:sx n="74" d="100"/>
          <a:sy n="74" d="100"/>
        </p:scale>
        <p:origin x="174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CF6BA-EC37-488F-B1F6-57F6CE0C85E7}" type="datetimeFigureOut">
              <a:rPr lang="en-CA" smtClean="0"/>
              <a:t>2017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CC89E-1C67-4873-AC91-D274277CEFC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10368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CF6BA-EC37-488F-B1F6-57F6CE0C85E7}" type="datetimeFigureOut">
              <a:rPr lang="en-CA" smtClean="0"/>
              <a:t>2017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CC89E-1C67-4873-AC91-D274277CEFC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65780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CF6BA-EC37-488F-B1F6-57F6CE0C85E7}" type="datetimeFigureOut">
              <a:rPr lang="en-CA" smtClean="0"/>
              <a:t>2017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CC89E-1C67-4873-AC91-D274277CEFC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0397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CF6BA-EC37-488F-B1F6-57F6CE0C85E7}" type="datetimeFigureOut">
              <a:rPr lang="en-CA" smtClean="0"/>
              <a:t>2017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CC89E-1C67-4873-AC91-D274277CEFC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33439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CF6BA-EC37-488F-B1F6-57F6CE0C85E7}" type="datetimeFigureOut">
              <a:rPr lang="en-CA" smtClean="0"/>
              <a:t>2017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CC89E-1C67-4873-AC91-D274277CEFC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05520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CF6BA-EC37-488F-B1F6-57F6CE0C85E7}" type="datetimeFigureOut">
              <a:rPr lang="en-CA" smtClean="0"/>
              <a:t>2017-11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CC89E-1C67-4873-AC91-D274277CEFC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24782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CF6BA-EC37-488F-B1F6-57F6CE0C85E7}" type="datetimeFigureOut">
              <a:rPr lang="en-CA" smtClean="0"/>
              <a:t>2017-11-1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CC89E-1C67-4873-AC91-D274277CEFC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56750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CF6BA-EC37-488F-B1F6-57F6CE0C85E7}" type="datetimeFigureOut">
              <a:rPr lang="en-CA" smtClean="0"/>
              <a:t>2017-11-1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CC89E-1C67-4873-AC91-D274277CEFC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67561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CF6BA-EC37-488F-B1F6-57F6CE0C85E7}" type="datetimeFigureOut">
              <a:rPr lang="en-CA" smtClean="0"/>
              <a:t>2017-11-1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CC89E-1C67-4873-AC91-D274277CEFC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983030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CF6BA-EC37-488F-B1F6-57F6CE0C85E7}" type="datetimeFigureOut">
              <a:rPr lang="en-CA" smtClean="0"/>
              <a:t>2017-11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CC89E-1C67-4873-AC91-D274277CEFC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40367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CF6BA-EC37-488F-B1F6-57F6CE0C85E7}" type="datetimeFigureOut">
              <a:rPr lang="en-CA" smtClean="0"/>
              <a:t>2017-11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CC89E-1C67-4873-AC91-D274277CEFC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15694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ACF6BA-EC37-488F-B1F6-57F6CE0C85E7}" type="datetimeFigureOut">
              <a:rPr lang="en-CA" smtClean="0"/>
              <a:t>2017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6CC89E-1C67-4873-AC91-D274277CEFC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60705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lowchart: Process 1"/>
          <p:cNvSpPr/>
          <p:nvPr/>
        </p:nvSpPr>
        <p:spPr>
          <a:xfrm>
            <a:off x="1132720" y="694943"/>
            <a:ext cx="4659998" cy="552166"/>
          </a:xfrm>
          <a:prstGeom prst="flowChartProcess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20821" tIns="10411" rIns="20821" bIns="1041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lculate AUROC for Hughes motifs, </a:t>
            </a:r>
            <a:r>
              <a:rPr lang="en-CA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ono</a:t>
            </a:r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otifs and other motifs for distinguishing the top 500 </a:t>
            </a:r>
            <a:r>
              <a:rPr lang="en-CA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eaks of all three data sets (Hughes, </a:t>
            </a:r>
            <a:r>
              <a:rPr lang="en-CA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ono</a:t>
            </a:r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riginal, </a:t>
            </a:r>
            <a:r>
              <a:rPr lang="en-CA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ono</a:t>
            </a:r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processed) from random dinucleotide shuffled sequences.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2190518" y="1246384"/>
            <a:ext cx="0" cy="1989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Flowchart: Decision 6"/>
          <p:cNvSpPr/>
          <p:nvPr/>
        </p:nvSpPr>
        <p:spPr>
          <a:xfrm>
            <a:off x="1264969" y="1450507"/>
            <a:ext cx="1836000" cy="1672859"/>
          </a:xfrm>
          <a:prstGeom prst="flowChartDecision">
            <a:avLst/>
          </a:prstGeom>
          <a:solidFill>
            <a:schemeClr val="accent1">
              <a:lumMod val="20000"/>
              <a:lumOff val="80000"/>
            </a:schemeClr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7" rIns="58293" bIns="291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ass A: </a:t>
            </a:r>
          </a:p>
          <a:p>
            <a:pPr algn="ctr"/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es a motif predict the test </a:t>
            </a:r>
            <a:r>
              <a:rPr lang="en-CA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ata sets better than the other motifs (AUROC &gt; 0.1 than the others)?</a:t>
            </a:r>
          </a:p>
        </p:txBody>
      </p:sp>
      <p:cxnSp>
        <p:nvCxnSpPr>
          <p:cNvPr id="9" name="Straight Arrow Connector 8"/>
          <p:cNvCxnSpPr/>
          <p:nvPr/>
        </p:nvCxnSpPr>
        <p:spPr>
          <a:xfrm rot="16200000" flipH="1">
            <a:off x="3264599" y="2136183"/>
            <a:ext cx="0" cy="306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 flipV="1">
            <a:off x="3432473" y="3779130"/>
            <a:ext cx="0" cy="452863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3059638" y="2048147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026936" y="3929991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13" name="Flowchart: Terminator 12"/>
          <p:cNvSpPr/>
          <p:nvPr/>
        </p:nvSpPr>
        <p:spPr>
          <a:xfrm>
            <a:off x="1726279" y="3566843"/>
            <a:ext cx="1053166" cy="424575"/>
          </a:xfrm>
          <a:prstGeom prst="flowChartTerminator">
            <a:avLst/>
          </a:prstGeom>
          <a:solidFill>
            <a:schemeClr val="accent4">
              <a:lumMod val="60000"/>
              <a:lumOff val="40000"/>
            </a:schemeClr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20821" tIns="10411" rIns="20821" bIns="1041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lect as the best motif</a:t>
            </a:r>
          </a:p>
        </p:txBody>
      </p:sp>
      <p:sp>
        <p:nvSpPr>
          <p:cNvPr id="14" name="Flowchart: Decision 13"/>
          <p:cNvSpPr/>
          <p:nvPr/>
        </p:nvSpPr>
        <p:spPr>
          <a:xfrm>
            <a:off x="3421672" y="1397714"/>
            <a:ext cx="2014231" cy="1798338"/>
          </a:xfrm>
          <a:prstGeom prst="flowChartDecision">
            <a:avLst/>
          </a:prstGeom>
          <a:solidFill>
            <a:schemeClr val="accent1">
              <a:lumMod val="20000"/>
              <a:lumOff val="80000"/>
            </a:schemeClr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7" rIns="58293" bIns="291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ass B: </a:t>
            </a:r>
          </a:p>
          <a:p>
            <a:pPr algn="ctr"/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es an in-vitro motif predict the test </a:t>
            </a:r>
            <a:r>
              <a:rPr lang="en-CA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ata sets almost as well as the </a:t>
            </a:r>
            <a:r>
              <a:rPr lang="en-CA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otifs (AUROC difference: 0.01-0.09)?</a:t>
            </a:r>
          </a:p>
        </p:txBody>
      </p:sp>
      <p:cxnSp>
        <p:nvCxnSpPr>
          <p:cNvPr id="16" name="Elbow Connector 15"/>
          <p:cNvCxnSpPr>
            <a:stCxn id="14" idx="2"/>
            <a:endCxn id="13" idx="3"/>
          </p:cNvCxnSpPr>
          <p:nvPr/>
        </p:nvCxnSpPr>
        <p:spPr>
          <a:xfrm rot="5400000">
            <a:off x="3312577" y="2662921"/>
            <a:ext cx="583078" cy="1649343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7296922" y="3661406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sp>
        <p:nvSpPr>
          <p:cNvPr id="20" name="Flowchart: Decision 19"/>
          <p:cNvSpPr/>
          <p:nvPr/>
        </p:nvSpPr>
        <p:spPr>
          <a:xfrm>
            <a:off x="5740962" y="1397715"/>
            <a:ext cx="1820150" cy="1798337"/>
          </a:xfrm>
          <a:prstGeom prst="flowChartDecision">
            <a:avLst/>
          </a:prstGeom>
          <a:solidFill>
            <a:schemeClr val="accent1">
              <a:lumMod val="20000"/>
              <a:lumOff val="80000"/>
            </a:schemeClr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7" rIns="58293" bIns="291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ass C:</a:t>
            </a:r>
          </a:p>
          <a:p>
            <a:pPr algn="ctr"/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 only one of the motif predictions supported by the recognition code (RCADE)?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010151" y="3357403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5419113" y="2057764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cxnSp>
        <p:nvCxnSpPr>
          <p:cNvPr id="42" name="Elbow Connector 41"/>
          <p:cNvCxnSpPr>
            <a:stCxn id="20" idx="3"/>
          </p:cNvCxnSpPr>
          <p:nvPr/>
        </p:nvCxnSpPr>
        <p:spPr>
          <a:xfrm flipH="1">
            <a:off x="7214331" y="2296883"/>
            <a:ext cx="346780" cy="3040720"/>
          </a:xfrm>
          <a:prstGeom prst="bentConnector4">
            <a:avLst>
              <a:gd name="adj1" fmla="val -27745"/>
              <a:gd name="adj2" fmla="val 100024"/>
            </a:avLst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Flowchart: Decision 44"/>
          <p:cNvSpPr/>
          <p:nvPr/>
        </p:nvSpPr>
        <p:spPr>
          <a:xfrm>
            <a:off x="4692535" y="4242826"/>
            <a:ext cx="2521795" cy="2180664"/>
          </a:xfrm>
          <a:prstGeom prst="flowChartDecision">
            <a:avLst/>
          </a:prstGeom>
          <a:solidFill>
            <a:schemeClr val="accent1">
              <a:lumMod val="20000"/>
              <a:lumOff val="80000"/>
            </a:schemeClr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8293" tIns="29147" rIns="58293" bIns="29147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ass D:</a:t>
            </a:r>
          </a:p>
          <a:p>
            <a:pPr algn="ctr"/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es an RCADE motif (or MEME motifs in the absence of any RCADE motif) predict the training </a:t>
            </a:r>
            <a:r>
              <a:rPr lang="en-CA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ata sets better than the other motifs? (AUROC &gt; 0.1 than the others) </a:t>
            </a:r>
          </a:p>
        </p:txBody>
      </p:sp>
      <p:cxnSp>
        <p:nvCxnSpPr>
          <p:cNvPr id="46" name="Straight Arrow Connector 45"/>
          <p:cNvCxnSpPr/>
          <p:nvPr/>
        </p:nvCxnSpPr>
        <p:spPr>
          <a:xfrm flipV="1">
            <a:off x="5943900" y="3762709"/>
            <a:ext cx="0" cy="4896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5566189" y="3901000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4386535" y="5085356"/>
            <a:ext cx="3817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900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sp>
        <p:nvSpPr>
          <p:cNvPr id="55" name="Flowchart: Decision 54"/>
          <p:cNvSpPr/>
          <p:nvPr/>
        </p:nvSpPr>
        <p:spPr>
          <a:xfrm>
            <a:off x="2490187" y="4242826"/>
            <a:ext cx="1884575" cy="2180665"/>
          </a:xfrm>
          <a:prstGeom prst="flowChartDecision">
            <a:avLst/>
          </a:prstGeom>
          <a:solidFill>
            <a:schemeClr val="accent1">
              <a:lumMod val="20000"/>
              <a:lumOff val="80000"/>
            </a:schemeClr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20821" tIns="10411" rIns="20821" bIns="1041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ass E: </a:t>
            </a:r>
          </a:p>
          <a:p>
            <a:pPr algn="ctr"/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es any of the motifs predict the test </a:t>
            </a:r>
            <a:r>
              <a:rPr lang="en-CA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ata sets slightly better than the others (AUROC difference: 0.01-0.09)?</a:t>
            </a:r>
          </a:p>
        </p:txBody>
      </p:sp>
      <p:cxnSp>
        <p:nvCxnSpPr>
          <p:cNvPr id="59" name="Elbow Connector 58"/>
          <p:cNvCxnSpPr>
            <a:endCxn id="13" idx="1"/>
          </p:cNvCxnSpPr>
          <p:nvPr/>
        </p:nvCxnSpPr>
        <p:spPr>
          <a:xfrm rot="5400000" flipH="1" flipV="1">
            <a:off x="881386" y="4164832"/>
            <a:ext cx="1230593" cy="459191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1753061" y="3183969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57" name="Flowchart: Process 56"/>
          <p:cNvSpPr/>
          <p:nvPr/>
        </p:nvSpPr>
        <p:spPr>
          <a:xfrm>
            <a:off x="44159" y="4999636"/>
            <a:ext cx="1654628" cy="686364"/>
          </a:xfrm>
          <a:prstGeom prst="flowChartProcess">
            <a:avLst/>
          </a:prstGeom>
          <a:solidFill>
            <a:schemeClr val="accent1">
              <a:lumMod val="20000"/>
              <a:lumOff val="80000"/>
            </a:schemeClr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20821" tIns="10411" rIns="20821" bIns="1041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ass F: </a:t>
            </a:r>
          </a:p>
          <a:p>
            <a:pPr algn="ctr"/>
            <a:r>
              <a:rPr lang="en-CA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sent all remaining motifs (single motifs or multiple motifs with similar criteria)</a:t>
            </a:r>
          </a:p>
        </p:txBody>
      </p:sp>
      <p:cxnSp>
        <p:nvCxnSpPr>
          <p:cNvPr id="63" name="Straight Arrow Connector 62"/>
          <p:cNvCxnSpPr/>
          <p:nvPr/>
        </p:nvCxnSpPr>
        <p:spPr>
          <a:xfrm rot="16200000" flipH="1">
            <a:off x="5596449" y="2143729"/>
            <a:ext cx="0" cy="306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Elbow Connector 81"/>
          <p:cNvCxnSpPr/>
          <p:nvPr/>
        </p:nvCxnSpPr>
        <p:spPr>
          <a:xfrm rot="10800000" flipV="1">
            <a:off x="4428729" y="3196051"/>
            <a:ext cx="2226440" cy="566658"/>
          </a:xfrm>
          <a:prstGeom prst="bentConnector3">
            <a:avLst>
              <a:gd name="adj1" fmla="val 178"/>
            </a:avLst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/>
          <p:cNvSpPr txBox="1"/>
          <p:nvPr/>
        </p:nvSpPr>
        <p:spPr>
          <a:xfrm>
            <a:off x="6236531" y="3357403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cxnSp>
        <p:nvCxnSpPr>
          <p:cNvPr id="91" name="Straight Arrow Connector 90"/>
          <p:cNvCxnSpPr/>
          <p:nvPr/>
        </p:nvCxnSpPr>
        <p:spPr>
          <a:xfrm rot="5400000">
            <a:off x="4527761" y="5184604"/>
            <a:ext cx="0" cy="306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/>
          <p:cNvSpPr txBox="1"/>
          <p:nvPr/>
        </p:nvSpPr>
        <p:spPr>
          <a:xfrm>
            <a:off x="1949048" y="5085356"/>
            <a:ext cx="3817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900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cxnSp>
        <p:nvCxnSpPr>
          <p:cNvPr id="100" name="Straight Arrow Connector 99"/>
          <p:cNvCxnSpPr/>
          <p:nvPr/>
        </p:nvCxnSpPr>
        <p:spPr>
          <a:xfrm flipH="1">
            <a:off x="1705534" y="5337604"/>
            <a:ext cx="779211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/>
          <p:nvPr/>
        </p:nvCxnSpPr>
        <p:spPr>
          <a:xfrm>
            <a:off x="2182969" y="3123366"/>
            <a:ext cx="0" cy="4284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Rectangle 2"/>
          <p:cNvSpPr/>
          <p:nvPr/>
        </p:nvSpPr>
        <p:spPr>
          <a:xfrm>
            <a:off x="347729" y="6997665"/>
            <a:ext cx="721338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latin typeface="Arial" panose="020B0604020202020204" pitchFamily="34" charset="0"/>
                <a:ea typeface="MS Mincho"/>
                <a:cs typeface="Times New Roman" panose="02020603050405020304" pitchFamily="18" charset="0"/>
              </a:rPr>
              <a:t>Figure S2.</a:t>
            </a:r>
            <a:r>
              <a:rPr lang="en-US" sz="1200" dirty="0">
                <a:latin typeface="Arial" panose="020B0604020202020204" pitchFamily="34" charset="0"/>
                <a:ea typeface="MS Mincho"/>
                <a:cs typeface="Times New Roman" panose="02020603050405020304" pitchFamily="18" charset="0"/>
              </a:rPr>
              <a:t> Ranking system for selection of the reference motif categorized in six classes (Class A-F).</a:t>
            </a:r>
            <a:endParaRPr lang="en-CA" sz="1200" dirty="0">
              <a:effectLst/>
              <a:latin typeface="Cambria" panose="02040503050406030204" pitchFamily="18" charset="0"/>
              <a:ea typeface="MS Mincho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20285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39</TotalTime>
  <Words>222</Words>
  <Application>Microsoft Office PowerPoint</Application>
  <PresentationFormat>Custom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Cambria</vt:lpstr>
      <vt:lpstr>MS Mincho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b1350</dc:creator>
  <cp:lastModifiedBy>Lab1350</cp:lastModifiedBy>
  <cp:revision>51</cp:revision>
  <dcterms:created xsi:type="dcterms:W3CDTF">2017-08-03T14:50:57Z</dcterms:created>
  <dcterms:modified xsi:type="dcterms:W3CDTF">2017-11-15T19:32:57Z</dcterms:modified>
</cp:coreProperties>
</file>